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62F8A-7244-473E-8717-C7DEECDB92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09779-6031-41A1-8224-34F40E2A91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2289E-3BA1-49C8-8F04-9C7A1616A9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4A31B-4CD9-49F2-8C98-EA167B6611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48B4C-BD04-45B7-A3D9-E751E58EC5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D7A5B-71EB-47D7-9C4D-13005FFDBD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048CC-2C5F-40FD-8FF9-B1BFE86CC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88898-401D-4338-855A-267D6979A8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497C0-E8C3-4C87-94FE-600039EE03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1C9E7-6A44-4F9E-83EC-2D813E28D7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655DF-98F8-4897-880B-A4B2E384FB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CF949-259F-483B-B6AD-DF230864B6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2C7738-6F3B-45BF-85A9-6E37F333BD6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304920" y="609480"/>
            <a:ext cx="899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1. Functional gene grouping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3"/>
          <p:cNvSpPr/>
          <p:nvPr/>
        </p:nvSpPr>
        <p:spPr>
          <a:xfrm>
            <a:off x="380880" y="914400"/>
            <a:ext cx="8305920" cy="0"/>
          </a:xfrm>
          <a:prstGeom prst="line">
            <a:avLst/>
          </a:prstGeom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5"/>
          <p:cNvSpPr/>
          <p:nvPr/>
        </p:nvSpPr>
        <p:spPr>
          <a:xfrm>
            <a:off x="304920" y="5791320"/>
            <a:ext cx="8305560" cy="0"/>
          </a:xfrm>
          <a:prstGeom prst="line">
            <a:avLst/>
          </a:prstGeom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380880" y="990720"/>
            <a:ext cx="8305920" cy="483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OPTOS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L, BRCA1, CIDIA, GADD45</a:t>
            </a:r>
            <a:r>
              <a:rPr b="0" i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ADD45</a:t>
            </a:r>
            <a:r>
              <a:rPr b="0" i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IP6K3,  PCBP4, AIFM1 (PDCD8), PPP1R15A, RAD21, p53, p7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ARRES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K1, CHK2, DDIT3 (CHOP), GADD45</a:t>
            </a:r>
            <a:r>
              <a:rPr b="0" i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GTSE1, HUS1, MAP2K6, MAPK12, PCBP4, PPP1R15A, RAD17, RAD9A, SESN1, ZAK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CHECK POIN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R, BRCA1, FANCG, NBN (NBS1), RAD1, RBBBP8, SMC1A(SMC1L1), p5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MAGED DNA BINDIN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KRD17, BRCA1, DDB1, DMC1, ERCC1, FANCG, FEN1, MPG, MSH2, MSH3, N4BP2, NBN (NBS1), OGG1, PMS2P3 (PMS2L9), PNKP, RAD1, RAD18, RAD51, RAD51B, REV1 (REV1L). SEMA4A, XPA, XPC, XRCC1, XRCC2, XRCC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CLEOTID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DB1, ERCC1, ERCC2 (XPD), LIG1, NTHL1, OGG1, PCNA, PNKP, RPA1,  p53, XPA, XP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S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UTYH, NTHL1, OGG1, UNG. APEX1, MBD4, MP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SMATCH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L1, ANKRD17, EXO1, MLH1, MLH3, MSH2, MSH3, MUTYH, N4BP2, PMS1, PMS2, PMS2P3 (PMS2L9), p73, TREX1.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UBLE STRAND BREAK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B1, FEN1, XRCC6 (G22P1), XRCC6BP1 (KUB3), MRE11A, MNN(NBS1), PRKDC, RAD21, RAD50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GENES RELATED TO DNA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M, ATRX, BTG2, CCNH, CDK7, CRY1, ERCC2 (XPD), GTF2H1, GTF2H2, IGHMBP2, LIG1, MNAT1, PCNA, RPA1, SUMO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24T21:50:44Z</dcterms:created>
  <dc:creator>Happy family</dc:creator>
  <dc:description/>
  <dc:language>en-US</dc:language>
  <cp:lastModifiedBy>Brechbiel, Martin (NIH/NCI) [E]</cp:lastModifiedBy>
  <dcterms:modified xsi:type="dcterms:W3CDTF">2016-05-11T15:45:30Z</dcterms:modified>
  <cp:revision>2</cp:revision>
  <dc:subject/>
  <dc:title>Slide 1</dc:title>
</cp:coreProperties>
</file>